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76" d="100"/>
          <a:sy n="76" d="100"/>
        </p:scale>
        <p:origin x="-16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0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100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110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75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688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11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494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13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10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20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41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280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55377" y="1679171"/>
            <a:ext cx="7633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/>
                <a:cs typeface="Arial"/>
              </a:rPr>
              <a:t>Table S2  </a:t>
            </a:r>
            <a:r>
              <a:rPr lang="en-US" dirty="0">
                <a:latin typeface="Arial"/>
                <a:cs typeface="Arial"/>
              </a:rPr>
              <a:t>Wild</a:t>
            </a:r>
            <a:r>
              <a:rPr lang="en-US" dirty="0" smtClean="0">
                <a:latin typeface="Arial"/>
                <a:cs typeface="Arial"/>
              </a:rPr>
              <a:t>-type response types in the presence of CdCl</a:t>
            </a:r>
            <a:r>
              <a:rPr lang="en-US" baseline="-25000" dirty="0" smtClean="0">
                <a:latin typeface="Arial"/>
                <a:cs typeface="Arial"/>
              </a:rPr>
              <a:t>2</a:t>
            </a:r>
            <a:r>
              <a:rPr lang="en-US" dirty="0" smtClean="0">
                <a:latin typeface="Arial"/>
                <a:cs typeface="Arial"/>
              </a:rPr>
              <a:t> (0.5mM).</a:t>
            </a:r>
            <a:endParaRPr lang="en-US" dirty="0">
              <a:latin typeface="Arial"/>
              <a:cs typeface="Arial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9382640"/>
              </p:ext>
            </p:extLst>
          </p:nvPr>
        </p:nvGraphicFramePr>
        <p:xfrm>
          <a:off x="1293170" y="2144269"/>
          <a:ext cx="7095453" cy="2655876"/>
        </p:xfrm>
        <a:graphic>
          <a:graphicData uri="http://schemas.openxmlformats.org/drawingml/2006/table">
            <a:tbl>
              <a:tblPr/>
              <a:tblGrid>
                <a:gridCol w="1688031"/>
                <a:gridCol w="1430535"/>
                <a:gridCol w="1659420"/>
                <a:gridCol w="1473451"/>
                <a:gridCol w="844016"/>
              </a:tblGrid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ponse typ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typ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hyper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ow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scill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d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FF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N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F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lti-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rrow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ra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1627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2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>UWS School of Medicine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orven Cameron</dc:creator>
  <cp:keywords/>
  <dc:description/>
  <cp:lastModifiedBy>Morven Cameron</cp:lastModifiedBy>
  <cp:revision>3</cp:revision>
  <dcterms:created xsi:type="dcterms:W3CDTF">2013-06-14T11:35:44Z</dcterms:created>
  <dcterms:modified xsi:type="dcterms:W3CDTF">2013-06-14T11:39:47Z</dcterms:modified>
  <cp:category/>
</cp:coreProperties>
</file>